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70" d="100"/>
          <a:sy n="70" d="100"/>
        </p:scale>
        <p:origin x="1704" y="-1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m Hui Kheng" userId="20939611-dc46-461c-b286-1e84dc82e1a3" providerId="ADAL" clId="{015E68B7-8B33-48AE-A645-3E779F6998CB}"/>
    <pc:docChg chg="modSld">
      <pc:chgData name="Lim Hui Kheng" userId="20939611-dc46-461c-b286-1e84dc82e1a3" providerId="ADAL" clId="{015E68B7-8B33-48AE-A645-3E779F6998CB}" dt="2025-03-05T06:50:50.959" v="4" actId="255"/>
      <pc:docMkLst>
        <pc:docMk/>
      </pc:docMkLst>
      <pc:sldChg chg="modSp mod">
        <pc:chgData name="Lim Hui Kheng" userId="20939611-dc46-461c-b286-1e84dc82e1a3" providerId="ADAL" clId="{015E68B7-8B33-48AE-A645-3E779F6998CB}" dt="2025-03-05T06:50:50.959" v="4" actId="255"/>
        <pc:sldMkLst>
          <pc:docMk/>
          <pc:sldMk cId="3223724961" sldId="274"/>
        </pc:sldMkLst>
        <pc:spChg chg="mod">
          <ac:chgData name="Lim Hui Kheng" userId="20939611-dc46-461c-b286-1e84dc82e1a3" providerId="ADAL" clId="{015E68B7-8B33-48AE-A645-3E779F6998CB}" dt="2025-03-05T06:50:50.959" v="4" actId="255"/>
          <ac:spMkLst>
            <pc:docMk/>
            <pc:sldMk cId="3223724961" sldId="274"/>
            <ac:spMk id="2" creationId="{302A83DE-AF7D-D2F2-2B11-E4FCFA093A41}"/>
          </ac:spMkLst>
        </pc:spChg>
      </pc:sldChg>
    </pc:docChg>
  </pc:docChgLst>
  <pc:docChgLst>
    <pc:chgData name="Lim Hui Kheng" userId="20939611-dc46-461c-b286-1e84dc82e1a3" providerId="ADAL" clId="{08E3AEBA-F855-4350-B15C-EF7DF0095719}"/>
    <pc:docChg chg="modSld">
      <pc:chgData name="Lim Hui Kheng" userId="20939611-dc46-461c-b286-1e84dc82e1a3" providerId="ADAL" clId="{08E3AEBA-F855-4350-B15C-EF7DF0095719}" dt="2025-03-11T05:33:42.530" v="14" actId="1035"/>
      <pc:docMkLst>
        <pc:docMk/>
      </pc:docMkLst>
      <pc:sldChg chg="modSp mod">
        <pc:chgData name="Lim Hui Kheng" userId="20939611-dc46-461c-b286-1e84dc82e1a3" providerId="ADAL" clId="{08E3AEBA-F855-4350-B15C-EF7DF0095719}" dt="2025-03-11T05:33:42.530" v="14" actId="1035"/>
        <pc:sldMkLst>
          <pc:docMk/>
          <pc:sldMk cId="3223724961" sldId="274"/>
        </pc:sldMkLst>
        <pc:spChg chg="mod">
          <ac:chgData name="Lim Hui Kheng" userId="20939611-dc46-461c-b286-1e84dc82e1a3" providerId="ADAL" clId="{08E3AEBA-F855-4350-B15C-EF7DF0095719}" dt="2025-03-11T05:33:42.530" v="14" actId="1035"/>
          <ac:spMkLst>
            <pc:docMk/>
            <pc:sldMk cId="3223724961" sldId="274"/>
            <ac:spMk id="3" creationId="{E1F78A60-8518-E245-905D-7FAB070AEF8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F4FF47-13FA-451B-8A83-99118A5497BF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F019A5-2382-4711-925E-054F814C3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7053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0F6DED-C42A-4DFF-8D5A-ADA28D9954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9908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95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697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265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87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030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079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4697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048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586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125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556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8DEC27-17C3-4919-96AD-3E46A8D9CFED}" type="datetimeFigureOut">
              <a:rPr lang="en-US" smtClean="0"/>
              <a:t>3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5C3818B-73B4-4A53-82E5-7EE428A275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173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5B37C5B-1896-0E3E-01E6-635AC81473A2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1056305"/>
          <a:ext cx="5915025" cy="81231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23396">
                  <a:extLst>
                    <a:ext uri="{9D8B030D-6E8A-4147-A177-3AD203B41FA5}">
                      <a16:colId xmlns:a16="http://schemas.microsoft.com/office/drawing/2014/main" val="86831567"/>
                    </a:ext>
                  </a:extLst>
                </a:gridCol>
                <a:gridCol w="563525">
                  <a:extLst>
                    <a:ext uri="{9D8B030D-6E8A-4147-A177-3AD203B41FA5}">
                      <a16:colId xmlns:a16="http://schemas.microsoft.com/office/drawing/2014/main" val="5565812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576759189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647242399"/>
                    </a:ext>
                  </a:extLst>
                </a:gridCol>
                <a:gridCol w="606056">
                  <a:extLst>
                    <a:ext uri="{9D8B030D-6E8A-4147-A177-3AD203B41FA5}">
                      <a16:colId xmlns:a16="http://schemas.microsoft.com/office/drawing/2014/main" val="1984561452"/>
                    </a:ext>
                  </a:extLst>
                </a:gridCol>
                <a:gridCol w="595423">
                  <a:extLst>
                    <a:ext uri="{9D8B030D-6E8A-4147-A177-3AD203B41FA5}">
                      <a16:colId xmlns:a16="http://schemas.microsoft.com/office/drawing/2014/main" val="700098098"/>
                    </a:ext>
                  </a:extLst>
                </a:gridCol>
                <a:gridCol w="574159">
                  <a:extLst>
                    <a:ext uri="{9D8B030D-6E8A-4147-A177-3AD203B41FA5}">
                      <a16:colId xmlns:a16="http://schemas.microsoft.com/office/drawing/2014/main" val="644283637"/>
                    </a:ext>
                  </a:extLst>
                </a:gridCol>
                <a:gridCol w="563525">
                  <a:extLst>
                    <a:ext uri="{9D8B030D-6E8A-4147-A177-3AD203B41FA5}">
                      <a16:colId xmlns:a16="http://schemas.microsoft.com/office/drawing/2014/main" val="3883630849"/>
                    </a:ext>
                  </a:extLst>
                </a:gridCol>
                <a:gridCol w="591769">
                  <a:extLst>
                    <a:ext uri="{9D8B030D-6E8A-4147-A177-3AD203B41FA5}">
                      <a16:colId xmlns:a16="http://schemas.microsoft.com/office/drawing/2014/main" val="3937868515"/>
                    </a:ext>
                  </a:extLst>
                </a:gridCol>
              </a:tblGrid>
              <a:tr h="127141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urcumin (µ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0712409"/>
                  </a:ext>
                </a:extLst>
              </a:tr>
              <a:tr h="13671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2 ± 0.1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5.06 ± 0.4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27 ± 0.4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5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68 ± 0.7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5 ± 0.0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8 ± 0.0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72036768"/>
                  </a:ext>
                </a:extLst>
              </a:tr>
              <a:tr h="136711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0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27 ± 0.4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3 ± 0.1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58 ± 1.2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4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74 ± 0.6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extLst>
                  <a:ext uri="{0D108BD9-81ED-4DB2-BD59-A6C34878D82A}">
                    <a16:rowId xmlns:a16="http://schemas.microsoft.com/office/drawing/2014/main" val="2230916413"/>
                  </a:ext>
                </a:extLst>
              </a:tr>
              <a:tr h="13671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0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13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7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53 ± 1.1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0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23 ± 0.5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extLst>
                  <a:ext uri="{0D108BD9-81ED-4DB2-BD59-A6C34878D82A}">
                    <a16:rowId xmlns:a16="http://schemas.microsoft.com/office/drawing/2014/main" val="1793300465"/>
                  </a:ext>
                </a:extLst>
              </a:tr>
              <a:tr h="13671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57 ± 0.3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3.57 ± 1.4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7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63 ± 1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/>
                </a:tc>
                <a:extLst>
                  <a:ext uri="{0D108BD9-81ED-4DB2-BD59-A6C34878D82A}">
                    <a16:rowId xmlns:a16="http://schemas.microsoft.com/office/drawing/2014/main" val="3806384264"/>
                  </a:ext>
                </a:extLst>
              </a:tr>
              <a:tr h="13671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70 ± 0.4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3.77 ± 1.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86 ±1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836" marR="6836" marT="683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4046905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67D6585-F0A7-A109-89B2-7A9F4CE020E3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1962861"/>
          <a:ext cx="5915025" cy="76595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23396">
                  <a:extLst>
                    <a:ext uri="{9D8B030D-6E8A-4147-A177-3AD203B41FA5}">
                      <a16:colId xmlns:a16="http://schemas.microsoft.com/office/drawing/2014/main" val="476238552"/>
                    </a:ext>
                  </a:extLst>
                </a:gridCol>
                <a:gridCol w="563525">
                  <a:extLst>
                    <a:ext uri="{9D8B030D-6E8A-4147-A177-3AD203B41FA5}">
                      <a16:colId xmlns:a16="http://schemas.microsoft.com/office/drawing/2014/main" val="1052482011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2297953946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1080127317"/>
                    </a:ext>
                  </a:extLst>
                </a:gridCol>
                <a:gridCol w="606056">
                  <a:extLst>
                    <a:ext uri="{9D8B030D-6E8A-4147-A177-3AD203B41FA5}">
                      <a16:colId xmlns:a16="http://schemas.microsoft.com/office/drawing/2014/main" val="314142628"/>
                    </a:ext>
                  </a:extLst>
                </a:gridCol>
                <a:gridCol w="595423">
                  <a:extLst>
                    <a:ext uri="{9D8B030D-6E8A-4147-A177-3AD203B41FA5}">
                      <a16:colId xmlns:a16="http://schemas.microsoft.com/office/drawing/2014/main" val="1122032502"/>
                    </a:ext>
                  </a:extLst>
                </a:gridCol>
                <a:gridCol w="574159">
                  <a:extLst>
                    <a:ext uri="{9D8B030D-6E8A-4147-A177-3AD203B41FA5}">
                      <a16:colId xmlns:a16="http://schemas.microsoft.com/office/drawing/2014/main" val="3101885169"/>
                    </a:ext>
                  </a:extLst>
                </a:gridCol>
                <a:gridCol w="563525">
                  <a:extLst>
                    <a:ext uri="{9D8B030D-6E8A-4147-A177-3AD203B41FA5}">
                      <a16:colId xmlns:a16="http://schemas.microsoft.com/office/drawing/2014/main" val="1332960788"/>
                    </a:ext>
                  </a:extLst>
                </a:gridCol>
                <a:gridCol w="591769">
                  <a:extLst>
                    <a:ext uri="{9D8B030D-6E8A-4147-A177-3AD203B41FA5}">
                      <a16:colId xmlns:a16="http://schemas.microsoft.com/office/drawing/2014/main" val="141751338"/>
                    </a:ext>
                  </a:extLst>
                </a:gridCol>
              </a:tblGrid>
              <a:tr h="106746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-HMF (</a:t>
                      </a:r>
                      <a:r>
                        <a:rPr lang="el-GR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6891619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62 ± 0.1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8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00 ± 0.5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8 ± 0.1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63 ± 0.7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70467271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0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80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2.80 ± 0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3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83 ± 0.2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1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extLst>
                  <a:ext uri="{0D108BD9-81ED-4DB2-BD59-A6C34878D82A}">
                    <a16:rowId xmlns:a16="http://schemas.microsoft.com/office/drawing/2014/main" val="3202907197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0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83 ± 0.3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7 ± 0.2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2.94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73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1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67 ± 0.2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1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extLst>
                  <a:ext uri="{0D108BD9-81ED-4DB2-BD59-A6C34878D82A}">
                    <a16:rowId xmlns:a16="http://schemas.microsoft.com/office/drawing/2014/main" val="483637550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0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6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3.70 ± 0.3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0 ± 0.0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40 ± 0.3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9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1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/>
                </a:tc>
                <a:extLst>
                  <a:ext uri="{0D108BD9-81ED-4DB2-BD59-A6C34878D82A}">
                    <a16:rowId xmlns:a16="http://schemas.microsoft.com/office/drawing/2014/main" val="3135612770"/>
                  </a:ext>
                </a:extLst>
              </a:tr>
              <a:tr h="114781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00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43 ± 0.2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0 ± 0.1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3.10 ± 0.5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7 ± 0.2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4.03 ± 0.1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1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39" marR="5739" marT="573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79912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5078CC7C-E74F-BD97-8BFF-58C3976B0B29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2821751"/>
          <a:ext cx="5915024" cy="7696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11449">
                  <a:extLst>
                    <a:ext uri="{9D8B030D-6E8A-4147-A177-3AD203B41FA5}">
                      <a16:colId xmlns:a16="http://schemas.microsoft.com/office/drawing/2014/main" val="3837191838"/>
                    </a:ext>
                  </a:extLst>
                </a:gridCol>
                <a:gridCol w="575473">
                  <a:extLst>
                    <a:ext uri="{9D8B030D-6E8A-4147-A177-3AD203B41FA5}">
                      <a16:colId xmlns:a16="http://schemas.microsoft.com/office/drawing/2014/main" val="260050816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3473573231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3772659041"/>
                    </a:ext>
                  </a:extLst>
                </a:gridCol>
                <a:gridCol w="606056">
                  <a:extLst>
                    <a:ext uri="{9D8B030D-6E8A-4147-A177-3AD203B41FA5}">
                      <a16:colId xmlns:a16="http://schemas.microsoft.com/office/drawing/2014/main" val="3779611205"/>
                    </a:ext>
                  </a:extLst>
                </a:gridCol>
                <a:gridCol w="595423">
                  <a:extLst>
                    <a:ext uri="{9D8B030D-6E8A-4147-A177-3AD203B41FA5}">
                      <a16:colId xmlns:a16="http://schemas.microsoft.com/office/drawing/2014/main" val="3925643566"/>
                    </a:ext>
                  </a:extLst>
                </a:gridCol>
                <a:gridCol w="584791">
                  <a:extLst>
                    <a:ext uri="{9D8B030D-6E8A-4147-A177-3AD203B41FA5}">
                      <a16:colId xmlns:a16="http://schemas.microsoft.com/office/drawing/2014/main" val="2364807278"/>
                    </a:ext>
                  </a:extLst>
                </a:gridCol>
                <a:gridCol w="552893">
                  <a:extLst>
                    <a:ext uri="{9D8B030D-6E8A-4147-A177-3AD203B41FA5}">
                      <a16:colId xmlns:a16="http://schemas.microsoft.com/office/drawing/2014/main" val="3185518766"/>
                    </a:ext>
                  </a:extLst>
                </a:gridCol>
                <a:gridCol w="591767">
                  <a:extLst>
                    <a:ext uri="{9D8B030D-6E8A-4147-A177-3AD203B41FA5}">
                      <a16:colId xmlns:a16="http://schemas.microsoft.com/office/drawing/2014/main" val="121790321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K-7 (µ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874027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45 ± 0.1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7 ± 0.0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31 ± 0.4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8 ± 0.1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41 ± 0.5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5 ± 0.0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405697655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20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9*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63 ± 0.5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0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80 ± 0.6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extLst>
                  <a:ext uri="{0D108BD9-81ED-4DB2-BD59-A6C34878D82A}">
                    <a16:rowId xmlns:a16="http://schemas.microsoft.com/office/drawing/2014/main" val="840674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00 ± 0.1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3.67 ± 1.2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3 ± 0.4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30 ± 1.1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7 ± 0.1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extLst>
                  <a:ext uri="{0D108BD9-81ED-4DB2-BD59-A6C34878D82A}">
                    <a16:rowId xmlns:a16="http://schemas.microsoft.com/office/drawing/2014/main" val="924500045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7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47 ± 0.3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7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10 ± 0.9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0 ± 0.3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80 ± 0.8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7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/>
                </a:tc>
                <a:extLst>
                  <a:ext uri="{0D108BD9-81ED-4DB2-BD59-A6C34878D82A}">
                    <a16:rowId xmlns:a16="http://schemas.microsoft.com/office/drawing/2014/main" val="1301341367"/>
                  </a:ext>
                </a:extLst>
              </a:tr>
              <a:tr h="127114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0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0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3.93 ± 0.8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9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3.30 ± 0.7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356" marR="6356" marT="635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2675365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84AA727D-C085-3DC4-1AA0-4A238886BB8A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3684343"/>
          <a:ext cx="5915026" cy="76608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02131">
                  <a:extLst>
                    <a:ext uri="{9D8B030D-6E8A-4147-A177-3AD203B41FA5}">
                      <a16:colId xmlns:a16="http://schemas.microsoft.com/office/drawing/2014/main" val="3639524004"/>
                    </a:ext>
                  </a:extLst>
                </a:gridCol>
                <a:gridCol w="596375">
                  <a:extLst>
                    <a:ext uri="{9D8B030D-6E8A-4147-A177-3AD203B41FA5}">
                      <a16:colId xmlns:a16="http://schemas.microsoft.com/office/drawing/2014/main" val="3763019656"/>
                    </a:ext>
                  </a:extLst>
                </a:gridCol>
                <a:gridCol w="637001">
                  <a:extLst>
                    <a:ext uri="{9D8B030D-6E8A-4147-A177-3AD203B41FA5}">
                      <a16:colId xmlns:a16="http://schemas.microsoft.com/office/drawing/2014/main" val="1077006198"/>
                    </a:ext>
                  </a:extLst>
                </a:gridCol>
                <a:gridCol w="659219">
                  <a:extLst>
                    <a:ext uri="{9D8B030D-6E8A-4147-A177-3AD203B41FA5}">
                      <a16:colId xmlns:a16="http://schemas.microsoft.com/office/drawing/2014/main" val="3548881222"/>
                    </a:ext>
                  </a:extLst>
                </a:gridCol>
                <a:gridCol w="584791">
                  <a:extLst>
                    <a:ext uri="{9D8B030D-6E8A-4147-A177-3AD203B41FA5}">
                      <a16:colId xmlns:a16="http://schemas.microsoft.com/office/drawing/2014/main" val="2128928834"/>
                    </a:ext>
                  </a:extLst>
                </a:gridCol>
                <a:gridCol w="616688">
                  <a:extLst>
                    <a:ext uri="{9D8B030D-6E8A-4147-A177-3AD203B41FA5}">
                      <a16:colId xmlns:a16="http://schemas.microsoft.com/office/drawing/2014/main" val="2934689588"/>
                    </a:ext>
                  </a:extLst>
                </a:gridCol>
                <a:gridCol w="574158">
                  <a:extLst>
                    <a:ext uri="{9D8B030D-6E8A-4147-A177-3AD203B41FA5}">
                      <a16:colId xmlns:a16="http://schemas.microsoft.com/office/drawing/2014/main" val="1635896993"/>
                    </a:ext>
                  </a:extLst>
                </a:gridCol>
                <a:gridCol w="552893">
                  <a:extLst>
                    <a:ext uri="{9D8B030D-6E8A-4147-A177-3AD203B41FA5}">
                      <a16:colId xmlns:a16="http://schemas.microsoft.com/office/drawing/2014/main" val="2043164333"/>
                    </a:ext>
                  </a:extLst>
                </a:gridCol>
                <a:gridCol w="591770">
                  <a:extLst>
                    <a:ext uri="{9D8B030D-6E8A-4147-A177-3AD203B41FA5}">
                      <a16:colId xmlns:a16="http://schemas.microsoft.com/office/drawing/2014/main" val="1856719982"/>
                    </a:ext>
                  </a:extLst>
                </a:gridCol>
              </a:tblGrid>
              <a:tr h="107162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ATX (µg/ml)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2151353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.31 ± 0.09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35 ± 0.1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4.46 ± 0.28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.02 ± 0.32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2.61 ± 0.61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3 ± 0.06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7 ± 0.02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259590563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6.2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.87 ± 0.29*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53 ± 0.09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2.03 ± 1.28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77 ± 0.2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4.57 ± 0.99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extLst>
                  <a:ext uri="{0D108BD9-81ED-4DB2-BD59-A6C34878D82A}">
                    <a16:rowId xmlns:a16="http://schemas.microsoft.com/office/drawing/2014/main" val="2368779246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31.2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2.21 ± 0.13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60 ± 0.32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0.46 ± 2.42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70 ± 0.15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3 ± 0.09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5.78 ± 2.61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0 ± 0.10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extLst>
                  <a:ext uri="{0D108BD9-81ED-4DB2-BD59-A6C34878D82A}">
                    <a16:rowId xmlns:a16="http://schemas.microsoft.com/office/drawing/2014/main" val="524474082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62.5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.70 ± 0.25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47 ± 0.19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2.43 ± 0.69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93 ± 0.26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4.20 ± 0.71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extLst>
                  <a:ext uri="{0D108BD9-81ED-4DB2-BD59-A6C34878D82A}">
                    <a16:rowId xmlns:a16="http://schemas.microsoft.com/office/drawing/2014/main" val="1793198558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25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1.94 ± 0.24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7 ± 0.12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92.55 ± 1.03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97 ± 0.27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4.07 ± 0.85</a:t>
                      </a:r>
                      <a:endParaRPr lang="en-SG" sz="800" b="0" i="0" u="none" strike="noStrike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</a:rPr>
                        <a:t>0.17 ± 0.12</a:t>
                      </a:r>
                      <a:endParaRPr lang="en-SG" sz="800" b="0" i="0" u="none" strike="noStrike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5820665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A950DCD4-6695-F032-4861-AF9FA1F73C28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4530086"/>
          <a:ext cx="5915026" cy="76608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080865">
                  <a:extLst>
                    <a:ext uri="{9D8B030D-6E8A-4147-A177-3AD203B41FA5}">
                      <a16:colId xmlns:a16="http://schemas.microsoft.com/office/drawing/2014/main" val="539383836"/>
                    </a:ext>
                  </a:extLst>
                </a:gridCol>
                <a:gridCol w="617641">
                  <a:extLst>
                    <a:ext uri="{9D8B030D-6E8A-4147-A177-3AD203B41FA5}">
                      <a16:colId xmlns:a16="http://schemas.microsoft.com/office/drawing/2014/main" val="3073210622"/>
                    </a:ext>
                  </a:extLst>
                </a:gridCol>
                <a:gridCol w="615736">
                  <a:extLst>
                    <a:ext uri="{9D8B030D-6E8A-4147-A177-3AD203B41FA5}">
                      <a16:colId xmlns:a16="http://schemas.microsoft.com/office/drawing/2014/main" val="3632544168"/>
                    </a:ext>
                  </a:extLst>
                </a:gridCol>
                <a:gridCol w="680484">
                  <a:extLst>
                    <a:ext uri="{9D8B030D-6E8A-4147-A177-3AD203B41FA5}">
                      <a16:colId xmlns:a16="http://schemas.microsoft.com/office/drawing/2014/main" val="1881651778"/>
                    </a:ext>
                  </a:extLst>
                </a:gridCol>
                <a:gridCol w="595423">
                  <a:extLst>
                    <a:ext uri="{9D8B030D-6E8A-4147-A177-3AD203B41FA5}">
                      <a16:colId xmlns:a16="http://schemas.microsoft.com/office/drawing/2014/main" val="2734081700"/>
                    </a:ext>
                  </a:extLst>
                </a:gridCol>
                <a:gridCol w="616689">
                  <a:extLst>
                    <a:ext uri="{9D8B030D-6E8A-4147-A177-3AD203B41FA5}">
                      <a16:colId xmlns:a16="http://schemas.microsoft.com/office/drawing/2014/main" val="2305749343"/>
                    </a:ext>
                  </a:extLst>
                </a:gridCol>
                <a:gridCol w="563525">
                  <a:extLst>
                    <a:ext uri="{9D8B030D-6E8A-4147-A177-3AD203B41FA5}">
                      <a16:colId xmlns:a16="http://schemas.microsoft.com/office/drawing/2014/main" val="3238589298"/>
                    </a:ext>
                  </a:extLst>
                </a:gridCol>
                <a:gridCol w="563526">
                  <a:extLst>
                    <a:ext uri="{9D8B030D-6E8A-4147-A177-3AD203B41FA5}">
                      <a16:colId xmlns:a16="http://schemas.microsoft.com/office/drawing/2014/main" val="4121534478"/>
                    </a:ext>
                  </a:extLst>
                </a:gridCol>
                <a:gridCol w="581137">
                  <a:extLst>
                    <a:ext uri="{9D8B030D-6E8A-4147-A177-3AD203B41FA5}">
                      <a16:colId xmlns:a16="http://schemas.microsoft.com/office/drawing/2014/main" val="1777193598"/>
                    </a:ext>
                  </a:extLst>
                </a:gridCol>
              </a:tblGrid>
              <a:tr h="107162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elamine (µ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4753318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25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30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4.69 ± 0.5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13 ± 0.4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34 ± 0.8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8 ± 0.0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95694296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62.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43 ± 0.3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4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5.20 ± 0.8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5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.10 ± 0.4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extLst>
                  <a:ext uri="{0D108BD9-81ED-4DB2-BD59-A6C34878D82A}">
                    <a16:rowId xmlns:a16="http://schemas.microsoft.com/office/drawing/2014/main" val="2910932533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2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46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5.18 ± 0.6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80 ± 0.2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86 ± 0.5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extLst>
                  <a:ext uri="{0D108BD9-81ED-4DB2-BD59-A6C34878D82A}">
                    <a16:rowId xmlns:a16="http://schemas.microsoft.com/office/drawing/2014/main" val="2317843866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2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07 ± 0.1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6.00 ± 0.8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7 ± 0.2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67 ± 0.6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/>
                </a:tc>
                <a:extLst>
                  <a:ext uri="{0D108BD9-81ED-4DB2-BD59-A6C34878D82A}">
                    <a16:rowId xmlns:a16="http://schemas.microsoft.com/office/drawing/2014/main" val="1718182439"/>
                  </a:ext>
                </a:extLst>
              </a:tr>
              <a:tr h="115228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5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36 ± 0.34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27 ± 0.0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95.51 ± 1.0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6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1.93 ± 0.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1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5761" marR="5761" marT="57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043234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02A83DE-AF7D-D2F2-2B11-E4FCFA093A41}"/>
              </a:ext>
            </a:extLst>
          </p:cNvPr>
          <p:cNvSpPr txBox="1"/>
          <p:nvPr/>
        </p:nvSpPr>
        <p:spPr>
          <a:xfrm>
            <a:off x="400049" y="661941"/>
            <a:ext cx="625329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SG" sz="1000" dirty="0">
                <a:effectLst/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2</a:t>
            </a:r>
            <a:r>
              <a:rPr lang="en-US" sz="1000" dirty="0">
                <a:latin typeface="Arial Narrow" panose="020B0606020202030204" pitchFamily="34" charset="0"/>
              </a:rPr>
              <a:t>: Cell phenotype and nuclear anomalies of non-DNA-reactive chemicals (including non-genotoxins) tested in </a:t>
            </a:r>
            <a:r>
              <a:rPr lang="en-SG" sz="1000" dirty="0"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Cyt assay</a:t>
            </a:r>
            <a:r>
              <a:rPr lang="en-US" sz="1000" dirty="0">
                <a:latin typeface="Arial Narrow" panose="020B0606020202030204" pitchFamily="34" charset="0"/>
              </a:rPr>
              <a:t> with 3D </a:t>
            </a:r>
            <a:r>
              <a:rPr lang="en-US" sz="1000" dirty="0" err="1">
                <a:latin typeface="Arial Narrow" panose="020B0606020202030204" pitchFamily="34" charset="0"/>
              </a:rPr>
              <a:t>EpiIntestinal</a:t>
            </a:r>
            <a:r>
              <a:rPr lang="en-US" sz="1000" dirty="0">
                <a:latin typeface="Arial Narrow" panose="020B0606020202030204" pitchFamily="34" charset="0"/>
              </a:rPr>
              <a:t>™ microtissu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1F78A60-8518-E245-905D-7FAB070AEF88}"/>
              </a:ext>
            </a:extLst>
          </p:cNvPr>
          <p:cNvSpPr txBox="1"/>
          <p:nvPr/>
        </p:nvSpPr>
        <p:spPr>
          <a:xfrm>
            <a:off x="435768" y="7069627"/>
            <a:ext cx="598646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SG" sz="1000" dirty="0">
                <a:latin typeface="Arial Narrow" panose="020B0606020202030204" pitchFamily="34" charset="0"/>
              </a:rPr>
              <a:t>5-HMF, 5-Hydroxymethylfurfural; MK-7, Menaquinone 7; ATX, </a:t>
            </a:r>
            <a:r>
              <a:rPr lang="en-SG" sz="1000" u="none" strike="noStrike" dirty="0">
                <a:solidFill>
                  <a:schemeClr val="tx1"/>
                </a:solidFill>
                <a:effectLst/>
              </a:rPr>
              <a:t>Astaxanthin;</a:t>
            </a:r>
            <a:r>
              <a:rPr lang="en-US" sz="1000" dirty="0">
                <a:latin typeface="Arial Narrow" panose="020B0606020202030204" pitchFamily="34" charset="0"/>
              </a:rPr>
              <a:t> MN, micronuclei; Buds, nuclear buds, Mono, mononucleated cells (basal and differentiated); BN, binucleated cells; CC, condensed chromatin; KR, karyorrhexis; PY, pyknosis; KL, </a:t>
            </a:r>
            <a:r>
              <a:rPr lang="en-US" sz="1000" dirty="0" err="1">
                <a:latin typeface="Arial Narrow" panose="020B0606020202030204" pitchFamily="34" charset="0"/>
              </a:rPr>
              <a:t>karyolysis</a:t>
            </a:r>
            <a:r>
              <a:rPr lang="en-US" sz="1000" dirty="0">
                <a:latin typeface="Arial Narrow" panose="020B0606020202030204" pitchFamily="34" charset="0"/>
              </a:rPr>
              <a:t>; 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0193706F-5080-A43D-835B-1C8358B80FA8}"/>
              </a:ext>
            </a:extLst>
          </p:cNvPr>
          <p:cNvGraphicFramePr>
            <a:graphicFrameLocks noGrp="1"/>
          </p:cNvGraphicFramePr>
          <p:nvPr/>
        </p:nvGraphicFramePr>
        <p:xfrm>
          <a:off x="471488" y="5365150"/>
          <a:ext cx="5915024" cy="77890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57527">
                  <a:extLst>
                    <a:ext uri="{9D8B030D-6E8A-4147-A177-3AD203B41FA5}">
                      <a16:colId xmlns:a16="http://schemas.microsoft.com/office/drawing/2014/main" val="1910917785"/>
                    </a:ext>
                  </a:extLst>
                </a:gridCol>
                <a:gridCol w="499462">
                  <a:extLst>
                    <a:ext uri="{9D8B030D-6E8A-4147-A177-3AD203B41FA5}">
                      <a16:colId xmlns:a16="http://schemas.microsoft.com/office/drawing/2014/main" val="2690200818"/>
                    </a:ext>
                  </a:extLst>
                </a:gridCol>
                <a:gridCol w="668511">
                  <a:extLst>
                    <a:ext uri="{9D8B030D-6E8A-4147-A177-3AD203B41FA5}">
                      <a16:colId xmlns:a16="http://schemas.microsoft.com/office/drawing/2014/main" val="1131034822"/>
                    </a:ext>
                  </a:extLst>
                </a:gridCol>
                <a:gridCol w="637775">
                  <a:extLst>
                    <a:ext uri="{9D8B030D-6E8A-4147-A177-3AD203B41FA5}">
                      <a16:colId xmlns:a16="http://schemas.microsoft.com/office/drawing/2014/main" val="415755308"/>
                    </a:ext>
                  </a:extLst>
                </a:gridCol>
                <a:gridCol w="653143">
                  <a:extLst>
                    <a:ext uri="{9D8B030D-6E8A-4147-A177-3AD203B41FA5}">
                      <a16:colId xmlns:a16="http://schemas.microsoft.com/office/drawing/2014/main" val="4236187123"/>
                    </a:ext>
                  </a:extLst>
                </a:gridCol>
                <a:gridCol w="591670">
                  <a:extLst>
                    <a:ext uri="{9D8B030D-6E8A-4147-A177-3AD203B41FA5}">
                      <a16:colId xmlns:a16="http://schemas.microsoft.com/office/drawing/2014/main" val="2241625970"/>
                    </a:ext>
                  </a:extLst>
                </a:gridCol>
                <a:gridCol w="576303">
                  <a:extLst>
                    <a:ext uri="{9D8B030D-6E8A-4147-A177-3AD203B41FA5}">
                      <a16:colId xmlns:a16="http://schemas.microsoft.com/office/drawing/2014/main" val="2295959306"/>
                    </a:ext>
                  </a:extLst>
                </a:gridCol>
                <a:gridCol w="553250">
                  <a:extLst>
                    <a:ext uri="{9D8B030D-6E8A-4147-A177-3AD203B41FA5}">
                      <a16:colId xmlns:a16="http://schemas.microsoft.com/office/drawing/2014/main" val="1269162034"/>
                    </a:ext>
                  </a:extLst>
                </a:gridCol>
                <a:gridCol w="577383">
                  <a:extLst>
                    <a:ext uri="{9D8B030D-6E8A-4147-A177-3AD203B41FA5}">
                      <a16:colId xmlns:a16="http://schemas.microsoft.com/office/drawing/2014/main" val="3508336842"/>
                    </a:ext>
                  </a:extLst>
                </a:gridCol>
              </a:tblGrid>
              <a:tr h="120989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Aspartame (µ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2459329"/>
                  </a:ext>
                </a:extLst>
              </a:tr>
              <a:tr h="130096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42 ± 0.1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45 ± 0.18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94.12 ± 0.9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1.22 ± 0.39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8 ± 0.0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2.62 ± 1.1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3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580251746"/>
                  </a:ext>
                </a:extLst>
              </a:tr>
              <a:tr h="130096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20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36 ± 0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33 ± 0.1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4.79 ± 0.8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50 ± 0.2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2.72 ± 0.7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3 ± 0.0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extLst>
                  <a:ext uri="{0D108BD9-81ED-4DB2-BD59-A6C34878D82A}">
                    <a16:rowId xmlns:a16="http://schemas.microsoft.com/office/drawing/2014/main" val="2910618400"/>
                  </a:ext>
                </a:extLst>
              </a:tr>
              <a:tr h="130096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0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50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5.30 ± 0.9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7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2.20 ± 0.6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extLst>
                  <a:ext uri="{0D108BD9-81ED-4DB2-BD59-A6C34878D82A}">
                    <a16:rowId xmlns:a16="http://schemas.microsoft.com/office/drawing/2014/main" val="3469552364"/>
                  </a:ext>
                </a:extLst>
              </a:tr>
              <a:tr h="130096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5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3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7 ± 0.1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5.73 ± 1.24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67 ± 0.2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87 ± 0.7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7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extLst>
                  <a:ext uri="{0D108BD9-81ED-4DB2-BD59-A6C34878D82A}">
                    <a16:rowId xmlns:a16="http://schemas.microsoft.com/office/drawing/2014/main" val="1382303992"/>
                  </a:ext>
                </a:extLst>
              </a:tr>
              <a:tr h="130096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2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2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3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5.63 ± 1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4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2.20 ± 0.9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505" marR="6505" marT="6505" marB="0" anchor="b"/>
                </a:tc>
                <a:extLst>
                  <a:ext uri="{0D108BD9-81ED-4DB2-BD59-A6C34878D82A}">
                    <a16:rowId xmlns:a16="http://schemas.microsoft.com/office/drawing/2014/main" val="460236957"/>
                  </a:ext>
                </a:extLst>
              </a:tr>
            </a:tbl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43FF58E4-D505-B5E4-97A2-19B3A7257BB7}"/>
              </a:ext>
            </a:extLst>
          </p:cNvPr>
          <p:cNvGraphicFramePr>
            <a:graphicFrameLocks noGrp="1"/>
          </p:cNvGraphicFramePr>
          <p:nvPr/>
        </p:nvGraphicFramePr>
        <p:xfrm>
          <a:off x="479834" y="6235748"/>
          <a:ext cx="5870958" cy="82092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58843">
                  <a:extLst>
                    <a:ext uri="{9D8B030D-6E8A-4147-A177-3AD203B41FA5}">
                      <a16:colId xmlns:a16="http://schemas.microsoft.com/office/drawing/2014/main" val="920244981"/>
                    </a:ext>
                  </a:extLst>
                </a:gridCol>
                <a:gridCol w="488887">
                  <a:extLst>
                    <a:ext uri="{9D8B030D-6E8A-4147-A177-3AD203B41FA5}">
                      <a16:colId xmlns:a16="http://schemas.microsoft.com/office/drawing/2014/main" val="1546783897"/>
                    </a:ext>
                  </a:extLst>
                </a:gridCol>
                <a:gridCol w="669957">
                  <a:extLst>
                    <a:ext uri="{9D8B030D-6E8A-4147-A177-3AD203B41FA5}">
                      <a16:colId xmlns:a16="http://schemas.microsoft.com/office/drawing/2014/main" val="3507175457"/>
                    </a:ext>
                  </a:extLst>
                </a:gridCol>
                <a:gridCol w="642796">
                  <a:extLst>
                    <a:ext uri="{9D8B030D-6E8A-4147-A177-3AD203B41FA5}">
                      <a16:colId xmlns:a16="http://schemas.microsoft.com/office/drawing/2014/main" val="26750309"/>
                    </a:ext>
                  </a:extLst>
                </a:gridCol>
                <a:gridCol w="642796">
                  <a:extLst>
                    <a:ext uri="{9D8B030D-6E8A-4147-A177-3AD203B41FA5}">
                      <a16:colId xmlns:a16="http://schemas.microsoft.com/office/drawing/2014/main" val="711480494"/>
                    </a:ext>
                  </a:extLst>
                </a:gridCol>
                <a:gridCol w="597529">
                  <a:extLst>
                    <a:ext uri="{9D8B030D-6E8A-4147-A177-3AD203B41FA5}">
                      <a16:colId xmlns:a16="http://schemas.microsoft.com/office/drawing/2014/main" val="1892478179"/>
                    </a:ext>
                  </a:extLst>
                </a:gridCol>
                <a:gridCol w="561314">
                  <a:extLst>
                    <a:ext uri="{9D8B030D-6E8A-4147-A177-3AD203B41FA5}">
                      <a16:colId xmlns:a16="http://schemas.microsoft.com/office/drawing/2014/main" val="1558202353"/>
                    </a:ext>
                  </a:extLst>
                </a:gridCol>
                <a:gridCol w="579422">
                  <a:extLst>
                    <a:ext uri="{9D8B030D-6E8A-4147-A177-3AD203B41FA5}">
                      <a16:colId xmlns:a16="http://schemas.microsoft.com/office/drawing/2014/main" val="1343483346"/>
                    </a:ext>
                  </a:extLst>
                </a:gridCol>
                <a:gridCol w="529414">
                  <a:extLst>
                    <a:ext uri="{9D8B030D-6E8A-4147-A177-3AD203B41FA5}">
                      <a16:colId xmlns:a16="http://schemas.microsoft.com/office/drawing/2014/main" val="2159348918"/>
                    </a:ext>
                  </a:extLst>
                </a:gridCol>
              </a:tblGrid>
              <a:tr h="128728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 err="1">
                          <a:effectLst/>
                          <a:latin typeface="Arial Narrow" panose="020B0606020202030204" pitchFamily="34" charset="0"/>
                        </a:rPr>
                        <a:t>d,l</a:t>
                      </a:r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-Menthol (</a:t>
                      </a:r>
                      <a:r>
                        <a:rPr lang="el-GR" sz="800" b="0" u="none" strike="noStrike" dirty="0">
                          <a:effectLst/>
                          <a:latin typeface="Arial Narrow" panose="020B0606020202030204" pitchFamily="34" charset="0"/>
                        </a:rPr>
                        <a:t>μ</a:t>
                      </a:r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g/ml)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MN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Buds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Mono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BN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CC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KR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PY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KL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5278873"/>
                  </a:ext>
                </a:extLst>
              </a:tr>
              <a:tr h="138417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% DMSO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1.08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37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4.67 ± 0.1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57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7 ± 0.07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3.08 ± 0.12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7 ± 0.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572892075"/>
                  </a:ext>
                </a:extLst>
              </a:tr>
              <a:tr h="138417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1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57 ± 0.2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2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3.60 ± 0.3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60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3 ± 0.1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3.63 ± 0.3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20 ± 0.10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extLst>
                  <a:ext uri="{0D108BD9-81ED-4DB2-BD59-A6C34878D82A}">
                    <a16:rowId xmlns:a16="http://schemas.microsoft.com/office/drawing/2014/main" val="2677568919"/>
                  </a:ext>
                </a:extLst>
              </a:tr>
              <a:tr h="138417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5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77 ± 0.18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20 ± 0.2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3.47 ± 0.4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73 ± 0.1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3.50 ± 0.35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3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3 ± 0.103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extLst>
                  <a:ext uri="{0D108BD9-81ED-4DB2-BD59-A6C34878D82A}">
                    <a16:rowId xmlns:a16="http://schemas.microsoft.com/office/drawing/2014/main" val="3382316728"/>
                  </a:ext>
                </a:extLst>
              </a:tr>
              <a:tr h="138417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2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30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37 ± 0.15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4.00 ± 0.4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53 ± 0.07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07 ± 0.03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3.33 ± 0.22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30 ± 0.1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/>
                </a:tc>
                <a:extLst>
                  <a:ext uri="{0D108BD9-81ED-4DB2-BD59-A6C34878D82A}">
                    <a16:rowId xmlns:a16="http://schemas.microsoft.com/office/drawing/2014/main" val="1350504390"/>
                  </a:ext>
                </a:extLst>
              </a:tr>
              <a:tr h="138417"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5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1.50 ± 0.21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33 ± 0.09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93.70 ± 0.6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7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0 ± 0.06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3.40 ± 0.3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>
                          <a:effectLst/>
                          <a:latin typeface="Arial Narrow" panose="020B0606020202030204" pitchFamily="34" charset="0"/>
                        </a:rPr>
                        <a:t>0.10 ± 0.00</a:t>
                      </a:r>
                      <a:endParaRPr lang="en-SG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800" b="0" u="none" strike="noStrike" dirty="0">
                          <a:effectLst/>
                          <a:latin typeface="Arial Narrow" panose="020B0606020202030204" pitchFamily="34" charset="0"/>
                        </a:rPr>
                        <a:t>0.17 ± 0.09</a:t>
                      </a:r>
                      <a:endParaRPr lang="en-SG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6921" marR="6921" marT="692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51680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23724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072</Words>
  <Application>Microsoft Office PowerPoint</Application>
  <PresentationFormat>A4 Paper (210x297 mm)</PresentationFormat>
  <Paragraphs>38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Arial Narro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m Hui Kheng</dc:creator>
  <cp:lastModifiedBy>Lim Hui Kheng</cp:lastModifiedBy>
  <cp:revision>1</cp:revision>
  <dcterms:created xsi:type="dcterms:W3CDTF">2025-01-27T06:17:03Z</dcterms:created>
  <dcterms:modified xsi:type="dcterms:W3CDTF">2025-03-11T05:33:49Z</dcterms:modified>
</cp:coreProperties>
</file>